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77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CBB12-F2F0-49D2-8021-C705D06E5C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5FFC2F7-8817-40AD-9BA8-EB0AC6FD08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B7141E-3956-4750-B372-B0986676C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677497-A116-4BFB-8A47-C06346DE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6A6FBE-8671-4777-B2B3-F94E88419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340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ED5E3-F1AA-449D-B9F8-1A40C0F48E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038282-1ABA-4D69-90EE-5328AB86E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3F7C64-2F8C-45BD-A194-1488A26A2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1FED6-2A02-4FA3-BEDD-CFDCB1021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839F02-F8B2-4D02-B374-AD1E63BDA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777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AD612E-0B49-48BD-8579-FF7813FABF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5CD227-A2C1-4E49-912C-2CD880B89A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74BD51-81BB-41D5-9514-507DCF331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C08BBB-5B93-47A2-83F3-8282B626B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A306A3-6186-456B-99EA-8AE385297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4127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63F9AC-FF3E-40C3-BB80-80F876689E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E7D5BF-8D36-4A7D-B6D9-97F3EE190D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DB2E52-2599-4A08-BCD3-D9F5A7C006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068FFC-B65A-4715-8CBD-F66B93B88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C85094-8585-4738-BCD4-44A46BDC2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778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B9BE1-ABBE-484C-8279-4594491A3B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F54373-4240-41D2-B9EF-356F1E5D8B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A41DCA-41BF-455B-A16C-5AE9EE5146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89A39A-8C8B-4FAE-934F-1B7ACBAA3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F23B2-C24F-468C-A0B1-22603C1E1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9172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46535-96DF-47FF-890F-9C11A10668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5D8EE9-0A13-45FB-9D79-07491C5FFD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63513B-4E27-408B-BE96-90D232A749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849B66-C4D6-42DA-A5BE-21F6D0856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F572A8C-116A-48D9-A408-6E5C94A50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A0BB2D-42A8-4FA8-82A3-9E2D9BCA5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07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7D018-75AB-4E0E-A103-9902BE1CFA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DD0544-E237-4AF6-A8DF-09714A3D87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E9EFE8-27BD-4DF2-9FFB-1AAC02B3DD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702314-35B9-4069-AC03-1407CBD63C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F642D6-6EDA-4100-9942-B9D9F25C14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0AB39B-FF35-4D39-8039-050E4797E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370A63-CDD2-48B5-A418-5C9BDFB31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25459F-2651-47E0-9C8C-3269275E1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9668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F12386-08C3-4973-9605-C639B121D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8F838E-3E5C-4641-9609-2E1F524C8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70F687-8D9F-4485-983C-DA621BB15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CC036E-C082-4054-BB82-969852B42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390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17FF1B-A05E-4F34-9154-345E2B421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53E0C5-0797-41C6-804B-AA0712B8F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12D4993-0944-4573-B0D6-F64999A64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3592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4B7AD-007F-49A9-81B7-8A8923546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5E54EC-4BC8-4392-A8C0-F9DC99F151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06F5C8-B9FF-45F4-B280-ACD1FA384F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127001-0944-483A-B7D4-5585579B0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13C8C5-A4A7-4BF7-8BCD-C57A76C27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11B6F3-950B-4092-BF33-FA3895814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313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424DE9-16D3-4B59-A2C7-8BA26D1D89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D0E0DB8-2869-41A6-AB1B-D5F40B404D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0B9B76-B198-42A3-9BE8-A377BED4E1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92EDA9-7294-4E82-9F6A-CA6E4C285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7BF1E6-0FBF-490A-A5E5-3FF760E40D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816FB6-9968-480B-8E48-5546888FA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955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5F784C-E075-4591-9B97-12D40A66F2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78A71D-1488-48C0-88E0-7CC1C62855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7133D6-852C-48A1-9083-C54E0F96E4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B04DF-A78C-4D7C-A04F-901C21F1601D}" type="datetimeFigureOut">
              <a:rPr lang="en-US" smtClean="0"/>
              <a:t>6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E169C6-7E3B-421E-88FC-351FAF6ED5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3550C1-B5DB-4EA7-AA2B-17EC60ADF2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8D3F3-47C9-4B49-977A-C632DD98B9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59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0C4527D-6E19-4142-91E4-AA2A0A785A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4171" y="929763"/>
            <a:ext cx="10691037" cy="2798148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44FDAC08-45E8-43F1-ADF2-9844108700F3}"/>
              </a:ext>
            </a:extLst>
          </p:cNvPr>
          <p:cNvSpPr/>
          <p:nvPr/>
        </p:nvSpPr>
        <p:spPr>
          <a:xfrm>
            <a:off x="355820" y="3975665"/>
            <a:ext cx="11480359" cy="26601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1. Images of hyphae in control samples of non- (or limited) </a:t>
            </a:r>
            <a:r>
              <a:rPr lang="en-US" sz="1400" b="1" i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usarium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fected samples using CLSM and pre-staining with WGA-Alexa Fluor 488.</a:t>
            </a:r>
            <a:r>
              <a:rPr lang="en-US" sz="14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a</a:t>
            </a:r>
            <a:r>
              <a:rPr lang="en-US" sz="14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yphae observed within the spongy parenchyma of barley husk; </a:t>
            </a: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b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hyphae within the furrow pericarp (P), and sieve element (SE) of wheat; </a:t>
            </a: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c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hyphae within the pericarp (P) and </a:t>
            </a:r>
            <a:r>
              <a:rPr lang="en-US" dirty="0" err="1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esta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T) of rye, but not in the aleurone layer (AL); and </a:t>
            </a: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d</a:t>
            </a:r>
            <a:r>
              <a:rPr lang="en-US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hyphae within the furrow seed coat (SC), vascular bundle (VB),  ETL, and under the nucellar projection (NP) of triticale. </a:t>
            </a:r>
            <a:endParaRPr lang="en-US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6E1D894-F3E1-46B1-BA51-71BB5FE5E333}"/>
              </a:ext>
            </a:extLst>
          </p:cNvPr>
          <p:cNvSpPr txBox="1"/>
          <p:nvPr/>
        </p:nvSpPr>
        <p:spPr>
          <a:xfrm>
            <a:off x="4955457" y="222183"/>
            <a:ext cx="22810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le </a:t>
            </a:r>
            <a:r>
              <a:rPr lang="en-US" b="1" dirty="0"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906900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17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yam Solanki</dc:creator>
  <cp:lastModifiedBy>Shyam Solanki</cp:lastModifiedBy>
  <cp:revision>3</cp:revision>
  <dcterms:created xsi:type="dcterms:W3CDTF">2020-06-07T04:02:11Z</dcterms:created>
  <dcterms:modified xsi:type="dcterms:W3CDTF">2020-06-07T04:09:08Z</dcterms:modified>
</cp:coreProperties>
</file>